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856"/>
    <p:restoredTop sz="94685"/>
  </p:normalViewPr>
  <p:slideViewPr>
    <p:cSldViewPr snapToGrid="0">
      <p:cViewPr varScale="1">
        <p:scale>
          <a:sx n="56" d="100"/>
          <a:sy n="56" d="100"/>
        </p:scale>
        <p:origin x="216" y="18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496AB9-CA63-8AEE-AD9F-8CE37D27A4A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D09E99-DEB6-6A80-31C4-4E4875760DD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1E1BDE-F056-2DFA-F995-A346D4E799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615CF4-1456-DA17-B0C0-11B1E3B7DD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220C70-AFE6-B0D0-2FDD-C022C85ED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307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5174C1-19A2-B2D3-B336-A2250DFA3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BBD1FF-EE8C-A4BC-B19D-D9D1E6967A0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BE89C9-69A1-08D7-E5DC-FCFF76FDE2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88ABB8-91A3-F9E5-3715-A931A52064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0949B2-9570-1765-711D-222C176BA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54270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E7CACF4-92E2-E69D-CD5F-F0225159715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FF73A7-D44B-8149-B0C9-A10BD663A1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236630-9124-BA43-4448-DE74BBCCC6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E35573-07D7-887B-3BD6-08136B150E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D4971C-996A-9855-771C-3F89CE943B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635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BA164C-0FE3-1CB6-0320-7F1579CF7C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BBA3074-A3BA-D37A-516F-0E9515C533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87DC94-7B5C-BA89-6A3E-373E292A3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7F91F8-379E-9816-BEAA-BF7F466CC9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85F5482-0961-0C7B-FEB1-85655D63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5122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0D9B1E-3097-7658-319D-9C5A58B8C9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28E0F-0B65-1378-E265-5EFDFD554E0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0F7EB3-3754-539D-6788-4FD94F053F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8D0C080-11F8-B6CE-045E-29F2A22E8A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255951-20E7-1017-9C75-81CF7BDC9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594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CAC7BA-7B3B-704D-DADD-38BD93390A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B34805-8E7F-0F18-0D70-4F519AA25C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E82A65-B49D-0AE6-9006-1CD7C396B5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446160-F456-8B8E-AF7E-153C1A9F96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73332A-EB51-E24F-AD46-938ECD0A1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1CBC18-B633-8344-A15D-F5100A6F28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97811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F6563E-9087-BEAA-6F6C-E6511EB5DB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11657D-590A-376B-C045-F5EB4E54AF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41A68-AFC5-AB0E-5AB3-0637586C72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BCFAB-533B-4D60-EF4F-2991CBB7F1E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9184C4F-9B9B-2CCD-9861-697B958D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1E1722-ACC1-A6D4-53FB-49525262FE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81FF02A-9AC2-D580-D6B4-83BE8FD37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003348-A871-92FE-48D0-8703CC14D4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4665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83A969-4F9B-3D20-F333-8805B8FEC6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48338F1-7FE3-AC2A-D162-35B8C197D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6D08145-6B9F-7B35-15B8-53CD83450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8EC5771-3C86-BBA8-ED9D-9AEA64C67E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651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40DB0D-4884-B0FA-6C60-451D8407F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7AA67AC-C267-3AAC-88EF-AA9743F2DE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E53D490-B0B5-1E28-CBAF-82383D4D8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5544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BD6ED0-982C-41D5-7A34-C58FD8BC7B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8C68C8-741F-7406-9F25-888C5BE788E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454FF4-AB34-0765-1D9C-9C4BCE3994A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D5E3397-D61D-CEDA-A7D2-44F89A1632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569A588-F086-79F5-EF61-7DE927E8B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B72A2-5FA6-5DC9-AFEA-8AACD6287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04738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6469D-676B-A09E-C366-0F8A954821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E8CA4FC-B488-C8EB-8463-4645D9A82A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BBB6D7-83DE-A0E6-7FE0-4A4CB1A179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4A4D87-2555-0DDE-96D3-77729943FD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5DD891-EEBE-5613-0012-D2C1FE8CE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AAC09B5-248A-8DF4-E27B-DEB87792F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32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F25BF80-CC22-8091-BB61-DB4BB41F91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A8B1A8-34E8-C37A-C9B5-08FEDA6909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265A5E-8218-C129-8C33-27B59130138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955773B-26B7-9C46-8AD3-650903738908}" type="datetimeFigureOut">
              <a:rPr lang="en-US" smtClean="0"/>
              <a:t>4/14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B8040C-BF7E-80C3-D71E-0CC4C88A58B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B685A5-CA66-4128-3CC1-7E6CB892E44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424FA89-ED8E-9042-8D1D-C3D7F122E9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07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E7B21B5-9A19-AD71-23D5-83C5F927115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Video 4">
            <a:hlinkClick r:id="" action="ppaction://media"/>
            <a:extLst>
              <a:ext uri="{FF2B5EF4-FFF2-40B4-BE49-F238E27FC236}">
                <a16:creationId xmlns:a16="http://schemas.microsoft.com/office/drawing/2014/main" id="{B9F05381-AC90-BC06-2FE6-3E7D74C7EEE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4763" y="9525"/>
            <a:ext cx="9469437" cy="68580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60DD86B-35C3-6315-783D-183570AC4857}"/>
              </a:ext>
            </a:extLst>
          </p:cNvPr>
          <p:cNvSpPr txBox="1"/>
          <p:nvPr/>
        </p:nvSpPr>
        <p:spPr>
          <a:xfrm>
            <a:off x="9761220" y="9525"/>
            <a:ext cx="2141855" cy="2585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deo 4: 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d-esophageal, long-axis cine by transesophageal echocardiography. Mobile masses seen on the aortic aspect of the prosthetic valve.</a:t>
            </a:r>
            <a:endParaRPr lang="en-US" sz="1800" kern="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65037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800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3</Words>
  <Application>Microsoft Macintosh PowerPoint</Application>
  <PresentationFormat>Widescreen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icrosoft Office User</dc:creator>
  <cp:lastModifiedBy>Microsoft Office User</cp:lastModifiedBy>
  <cp:revision>6</cp:revision>
  <dcterms:created xsi:type="dcterms:W3CDTF">2025-04-14T20:40:00Z</dcterms:created>
  <dcterms:modified xsi:type="dcterms:W3CDTF">2025-04-14T20:43:47Z</dcterms:modified>
</cp:coreProperties>
</file>